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5" d="100"/>
          <a:sy n="115" d="100"/>
        </p:scale>
        <p:origin x="2316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8816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5053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6266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0698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7144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4351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5507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6118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8168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7519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2431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60783FB-FCAF-4B23-935A-D0B2537920BF}" type="datetimeFigureOut">
              <a:rPr lang="ko-KR" altLang="en-US" smtClean="0"/>
              <a:t>2025-04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FF15A3-F6E5-4AC7-823D-69673D5B1D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2142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869C5CDB-5372-8797-6F6D-BF9CBC9CE0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8721" y="71718"/>
            <a:ext cx="5680557" cy="57023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056028-7114-7E43-F03B-1DFCADC1D211}"/>
              </a:ext>
            </a:extLst>
          </p:cNvPr>
          <p:cNvSpPr txBox="1"/>
          <p:nvPr/>
        </p:nvSpPr>
        <p:spPr>
          <a:xfrm>
            <a:off x="478558" y="6085074"/>
            <a:ext cx="55149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ko-KR" sz="1000" b="1" dirty="0">
                <a:latin typeface="URWPalladioL-Bold"/>
              </a:rPr>
              <a:t>Figure S1. </a:t>
            </a:r>
            <a:r>
              <a:rPr lang="en-US" altLang="ko-KR" sz="1000" dirty="0"/>
              <a:t>Time from blood culture positivity to preparation initiation for Filmarray BCID2, stratified by on-duty and off-duty hours (</a:t>
            </a:r>
            <a:r>
              <a:rPr lang="en-US" altLang="ko-KR" sz="1000" i="1" dirty="0"/>
              <a:t>p</a:t>
            </a:r>
            <a:r>
              <a:rPr lang="en-US" altLang="ko-KR" sz="1000" dirty="0"/>
              <a:t> &lt;0.0005).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430012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05</TotalTime>
  <Words>26</Words>
  <Application>Microsoft Office PowerPoint</Application>
  <PresentationFormat>A4 용지(210x297mm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URWPalladioL-Bold</vt:lpstr>
      <vt:lpstr>Aptos</vt:lpstr>
      <vt:lpstr>Aptos Display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성균 박</dc:creator>
  <cp:lastModifiedBy>성균 박</cp:lastModifiedBy>
  <cp:revision>23</cp:revision>
  <dcterms:created xsi:type="dcterms:W3CDTF">2025-03-07T07:07:57Z</dcterms:created>
  <dcterms:modified xsi:type="dcterms:W3CDTF">2025-04-01T10:40:52Z</dcterms:modified>
</cp:coreProperties>
</file>